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8" r:id="rId2"/>
  </p:sldIdLst>
  <p:sldSz cx="9144000" cy="6858000" type="screen4x3"/>
  <p:notesSz cx="6797675" cy="9926638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0E0E0"/>
    <a:srgbClr val="ECECE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940675A-B579-460E-94D1-54222C63F5DA}" styleName="Nessuno stile, griglia tabel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88" autoAdjust="0"/>
    <p:restoredTop sz="90598" autoAdjust="0"/>
  </p:normalViewPr>
  <p:slideViewPr>
    <p:cSldViewPr>
      <p:cViewPr>
        <p:scale>
          <a:sx n="90" d="100"/>
          <a:sy n="90" d="100"/>
        </p:scale>
        <p:origin x="-642" y="-29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B7B53EF-3AE7-484E-9BAC-564CAAF4E700}" type="datetimeFigureOut">
              <a:rPr lang="it-IT" smtClean="0"/>
              <a:pPr/>
              <a:t>15/10/2018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BDA31B0-2556-4684-8750-BF1D8261D7A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89989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5/10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609616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5/10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367629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5/10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767782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5/10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198881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5/10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629044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5/10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104353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5/10/2018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318641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5/10/2018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583139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5/10/2018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915458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5/10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869255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5/10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965482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9BB526-5326-432C-B1B9-8029C7855CE6}" type="datetimeFigureOut">
              <a:rPr lang="it-IT" smtClean="0"/>
              <a:pPr/>
              <a:t>15/10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753571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107504" y="0"/>
            <a:ext cx="4536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itchFamily="18" charset="0"/>
                <a:cs typeface="Times New Roman" pitchFamily="18" charset="0"/>
              </a:rPr>
              <a:t>Figura S4</a:t>
            </a:r>
            <a:endParaRPr lang="it-IT" sz="1200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56" name="Gruppo 55"/>
          <p:cNvGrpSpPr/>
          <p:nvPr/>
        </p:nvGrpSpPr>
        <p:grpSpPr>
          <a:xfrm>
            <a:off x="1049908" y="271987"/>
            <a:ext cx="7163899" cy="3251119"/>
            <a:chOff x="1049908" y="271987"/>
            <a:chExt cx="7163899" cy="3251119"/>
          </a:xfrm>
        </p:grpSpPr>
        <p:sp>
          <p:nvSpPr>
            <p:cNvPr id="10" name="CasellaDiTesto 9"/>
            <p:cNvSpPr txBox="1"/>
            <p:nvPr/>
          </p:nvSpPr>
          <p:spPr>
            <a:xfrm>
              <a:off x="1049908" y="271987"/>
              <a:ext cx="36004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3" name="Gruppo 22"/>
            <p:cNvGrpSpPr/>
            <p:nvPr/>
          </p:nvGrpSpPr>
          <p:grpSpPr>
            <a:xfrm>
              <a:off x="1187734" y="327479"/>
              <a:ext cx="7026073" cy="3195627"/>
              <a:chOff x="1187734" y="327479"/>
              <a:chExt cx="7026073" cy="3195627"/>
            </a:xfrm>
          </p:grpSpPr>
          <p:grpSp>
            <p:nvGrpSpPr>
              <p:cNvPr id="8" name="Gruppo 7"/>
              <p:cNvGrpSpPr/>
              <p:nvPr/>
            </p:nvGrpSpPr>
            <p:grpSpPr>
              <a:xfrm>
                <a:off x="1187734" y="327479"/>
                <a:ext cx="7026073" cy="3195627"/>
                <a:chOff x="-5801" y="3499693"/>
                <a:chExt cx="7026073" cy="3349515"/>
              </a:xfrm>
            </p:grpSpPr>
            <p:grpSp>
              <p:nvGrpSpPr>
                <p:cNvPr id="24" name="Gruppo 23"/>
                <p:cNvGrpSpPr/>
                <p:nvPr/>
              </p:nvGrpSpPr>
              <p:grpSpPr>
                <a:xfrm>
                  <a:off x="30861" y="3789040"/>
                  <a:ext cx="1800000" cy="1548000"/>
                  <a:chOff x="395536" y="1556792"/>
                  <a:chExt cx="2592288" cy="2088000"/>
                </a:xfrm>
              </p:grpSpPr>
              <p:pic>
                <p:nvPicPr>
                  <p:cNvPr id="25" name="Picture 10"/>
                  <p:cNvPicPr>
                    <a:picLocks noChangeAspect="1" noChangeArrowheads="1"/>
                  </p:cNvPicPr>
                  <p:nvPr/>
                </p:nvPicPr>
                <p:blipFill>
                  <a:blip r:embed="rId2" cstate="print"/>
                  <a:srcRect/>
                  <a:stretch>
                    <a:fillRect/>
                  </a:stretch>
                </p:blipFill>
                <p:spPr bwMode="auto">
                  <a:xfrm>
                    <a:off x="395536" y="1556792"/>
                    <a:ext cx="2244455" cy="208800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</p:pic>
              <p:sp>
                <p:nvSpPr>
                  <p:cNvPr id="27" name="CasellaDiTesto 26"/>
                  <p:cNvSpPr txBox="1"/>
                  <p:nvPr/>
                </p:nvSpPr>
                <p:spPr>
                  <a:xfrm>
                    <a:off x="1979712" y="1749294"/>
                    <a:ext cx="1008112" cy="21544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it-IT" sz="800" b="1" dirty="0" smtClean="0">
                        <a:latin typeface="Times New Roman" pitchFamily="18" charset="0"/>
                        <a:cs typeface="Times New Roman" pitchFamily="18" charset="0"/>
                      </a:rPr>
                      <a:t>p=0.24</a:t>
                    </a:r>
                    <a:endParaRPr lang="it-IT" sz="8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</p:grpSp>
            <p:grpSp>
              <p:nvGrpSpPr>
                <p:cNvPr id="28" name="Gruppo 27"/>
                <p:cNvGrpSpPr/>
                <p:nvPr/>
              </p:nvGrpSpPr>
              <p:grpSpPr>
                <a:xfrm>
                  <a:off x="3465043" y="3807022"/>
                  <a:ext cx="1605659" cy="1548000"/>
                  <a:chOff x="5508104" y="1033273"/>
                  <a:chExt cx="2248172" cy="1656000"/>
                </a:xfrm>
              </p:grpSpPr>
              <p:pic>
                <p:nvPicPr>
                  <p:cNvPr id="29" name="Picture 12"/>
                  <p:cNvPicPr>
                    <a:picLocks noChangeArrowheads="1"/>
                  </p:cNvPicPr>
                  <p:nvPr/>
                </p:nvPicPr>
                <p:blipFill>
                  <a:blip r:embed="rId3" cstate="print"/>
                  <a:srcRect/>
                  <a:stretch>
                    <a:fillRect/>
                  </a:stretch>
                </p:blipFill>
                <p:spPr bwMode="auto">
                  <a:xfrm>
                    <a:off x="5508104" y="1033273"/>
                    <a:ext cx="2019455" cy="165600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</p:pic>
              <p:sp>
                <p:nvSpPr>
                  <p:cNvPr id="30" name="CasellaDiTesto 29"/>
                  <p:cNvSpPr txBox="1"/>
                  <p:nvPr/>
                </p:nvSpPr>
                <p:spPr>
                  <a:xfrm>
                    <a:off x="6748164" y="1189585"/>
                    <a:ext cx="100811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it-IT" sz="800" b="1" dirty="0" smtClean="0">
                        <a:latin typeface="Times New Roman" pitchFamily="18" charset="0"/>
                        <a:cs typeface="Times New Roman" pitchFamily="18" charset="0"/>
                      </a:rPr>
                      <a:t>p=0.0006</a:t>
                    </a:r>
                    <a:endParaRPr lang="it-IT" sz="8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</p:grpSp>
            <p:grpSp>
              <p:nvGrpSpPr>
                <p:cNvPr id="31" name="Gruppo 30"/>
                <p:cNvGrpSpPr/>
                <p:nvPr/>
              </p:nvGrpSpPr>
              <p:grpSpPr>
                <a:xfrm>
                  <a:off x="5217713" y="3825216"/>
                  <a:ext cx="1800000" cy="1548000"/>
                  <a:chOff x="0" y="4221088"/>
                  <a:chExt cx="2402029" cy="2089807"/>
                </a:xfrm>
              </p:grpSpPr>
              <p:pic>
                <p:nvPicPr>
                  <p:cNvPr id="32" name="Picture 13"/>
                  <p:cNvPicPr>
                    <a:picLocks noChangeAspect="1" noChangeArrowheads="1"/>
                  </p:cNvPicPr>
                  <p:nvPr/>
                </p:nvPicPr>
                <p:blipFill>
                  <a:blip r:embed="rId4" cstate="print"/>
                  <a:srcRect/>
                  <a:stretch>
                    <a:fillRect/>
                  </a:stretch>
                </p:blipFill>
                <p:spPr bwMode="auto">
                  <a:xfrm>
                    <a:off x="0" y="4221088"/>
                    <a:ext cx="2246400" cy="20898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</p:pic>
              <p:sp>
                <p:nvSpPr>
                  <p:cNvPr id="33" name="CasellaDiTesto 32"/>
                  <p:cNvSpPr txBox="1"/>
                  <p:nvPr/>
                </p:nvSpPr>
                <p:spPr>
                  <a:xfrm>
                    <a:off x="1475656" y="4365104"/>
                    <a:ext cx="926373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it-IT" sz="800" b="1" dirty="0" smtClean="0">
                        <a:latin typeface="Times New Roman" pitchFamily="18" charset="0"/>
                        <a:cs typeface="Times New Roman" pitchFamily="18" charset="0"/>
                      </a:rPr>
                      <a:t>p=0.02</a:t>
                    </a:r>
                    <a:endParaRPr lang="it-IT" sz="8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</p:grpSp>
            <p:grpSp>
              <p:nvGrpSpPr>
                <p:cNvPr id="34" name="Gruppo 33"/>
                <p:cNvGrpSpPr/>
                <p:nvPr/>
              </p:nvGrpSpPr>
              <p:grpSpPr>
                <a:xfrm>
                  <a:off x="-5801" y="5301208"/>
                  <a:ext cx="1845365" cy="1548000"/>
                  <a:chOff x="1187624" y="3501008"/>
                  <a:chExt cx="2303016" cy="2089807"/>
                </a:xfrm>
              </p:grpSpPr>
              <p:pic>
                <p:nvPicPr>
                  <p:cNvPr id="35" name="Picture 14"/>
                  <p:cNvPicPr>
                    <a:picLocks noChangeAspect="1" noChangeArrowheads="1"/>
                  </p:cNvPicPr>
                  <p:nvPr/>
                </p:nvPicPr>
                <p:blipFill>
                  <a:blip r:embed="rId5" cstate="print"/>
                  <a:srcRect/>
                  <a:stretch>
                    <a:fillRect/>
                  </a:stretch>
                </p:blipFill>
                <p:spPr bwMode="auto">
                  <a:xfrm>
                    <a:off x="1187624" y="3501008"/>
                    <a:ext cx="2246400" cy="20898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</p:pic>
              <p:sp>
                <p:nvSpPr>
                  <p:cNvPr id="37" name="CasellaDiTesto 36"/>
                  <p:cNvSpPr txBox="1"/>
                  <p:nvPr/>
                </p:nvSpPr>
                <p:spPr>
                  <a:xfrm>
                    <a:off x="2699792" y="3645024"/>
                    <a:ext cx="790848" cy="29085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it-IT" sz="800" b="1" dirty="0" smtClean="0">
                        <a:latin typeface="Times New Roman" pitchFamily="18" charset="0"/>
                        <a:cs typeface="Times New Roman" pitchFamily="18" charset="0"/>
                      </a:rPr>
                      <a:t>p=0.005</a:t>
                    </a:r>
                    <a:endParaRPr lang="it-IT" sz="8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</p:grpSp>
            <p:grpSp>
              <p:nvGrpSpPr>
                <p:cNvPr id="39" name="Gruppo 38"/>
                <p:cNvGrpSpPr/>
                <p:nvPr/>
              </p:nvGrpSpPr>
              <p:grpSpPr>
                <a:xfrm>
                  <a:off x="1705459" y="5301208"/>
                  <a:ext cx="1800000" cy="1548000"/>
                  <a:chOff x="3491880" y="3356992"/>
                  <a:chExt cx="2520280" cy="2089807"/>
                </a:xfrm>
              </p:grpSpPr>
              <p:pic>
                <p:nvPicPr>
                  <p:cNvPr id="41" name="Picture 15"/>
                  <p:cNvPicPr>
                    <a:picLocks noChangeAspect="1" noChangeArrowheads="1"/>
                  </p:cNvPicPr>
                  <p:nvPr/>
                </p:nvPicPr>
                <p:blipFill>
                  <a:blip r:embed="rId6" cstate="print"/>
                  <a:srcRect/>
                  <a:stretch>
                    <a:fillRect/>
                  </a:stretch>
                </p:blipFill>
                <p:spPr bwMode="auto">
                  <a:xfrm>
                    <a:off x="3491880" y="3356992"/>
                    <a:ext cx="2246400" cy="20898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</p:pic>
              <p:sp>
                <p:nvSpPr>
                  <p:cNvPr id="44" name="CasellaDiTesto 43"/>
                  <p:cNvSpPr txBox="1"/>
                  <p:nvPr/>
                </p:nvSpPr>
                <p:spPr>
                  <a:xfrm>
                    <a:off x="5004048" y="3501008"/>
                    <a:ext cx="100811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it-IT" sz="800" b="1" dirty="0" smtClean="0">
                        <a:latin typeface="Times New Roman" pitchFamily="18" charset="0"/>
                        <a:cs typeface="Times New Roman" pitchFamily="18" charset="0"/>
                      </a:rPr>
                      <a:t>p=0.01</a:t>
                    </a:r>
                    <a:endParaRPr lang="it-IT" sz="8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</p:grpSp>
            <p:grpSp>
              <p:nvGrpSpPr>
                <p:cNvPr id="46" name="Gruppo 45"/>
                <p:cNvGrpSpPr/>
                <p:nvPr/>
              </p:nvGrpSpPr>
              <p:grpSpPr>
                <a:xfrm>
                  <a:off x="3433529" y="5301208"/>
                  <a:ext cx="1800000" cy="1548000"/>
                  <a:chOff x="5724128" y="4077072"/>
                  <a:chExt cx="2520280" cy="2246400"/>
                </a:xfrm>
              </p:grpSpPr>
              <p:pic>
                <p:nvPicPr>
                  <p:cNvPr id="48" name="Picture 16"/>
                  <p:cNvPicPr>
                    <a:picLocks noChangeAspect="1" noChangeArrowheads="1"/>
                  </p:cNvPicPr>
                  <p:nvPr/>
                </p:nvPicPr>
                <p:blipFill>
                  <a:blip r:embed="rId7" cstate="print"/>
                  <a:srcRect/>
                  <a:stretch>
                    <a:fillRect/>
                  </a:stretch>
                </p:blipFill>
                <p:spPr bwMode="auto">
                  <a:xfrm>
                    <a:off x="5724128" y="4077072"/>
                    <a:ext cx="2246400" cy="224640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</p:pic>
              <p:sp>
                <p:nvSpPr>
                  <p:cNvPr id="49" name="CasellaDiTesto 48"/>
                  <p:cNvSpPr txBox="1"/>
                  <p:nvPr/>
                </p:nvSpPr>
                <p:spPr>
                  <a:xfrm>
                    <a:off x="7236296" y="4307828"/>
                    <a:ext cx="100811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it-IT" sz="800" b="1" dirty="0" smtClean="0">
                        <a:latin typeface="Times New Roman" pitchFamily="18" charset="0"/>
                        <a:cs typeface="Times New Roman" pitchFamily="18" charset="0"/>
                      </a:rPr>
                      <a:t>p=0.09</a:t>
                    </a:r>
                    <a:endParaRPr lang="it-IT" sz="8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</p:grpSp>
            <p:grpSp>
              <p:nvGrpSpPr>
                <p:cNvPr id="50" name="Gruppo 49"/>
                <p:cNvGrpSpPr/>
                <p:nvPr/>
              </p:nvGrpSpPr>
              <p:grpSpPr>
                <a:xfrm>
                  <a:off x="1665819" y="3825216"/>
                  <a:ext cx="1746647" cy="1548000"/>
                  <a:chOff x="2590802" y="1585927"/>
                  <a:chExt cx="2481464" cy="2076411"/>
                </a:xfrm>
              </p:grpSpPr>
              <p:pic>
                <p:nvPicPr>
                  <p:cNvPr id="51" name="Picture 19"/>
                  <p:cNvPicPr>
                    <a:picLocks noChangeAspect="1" noChangeArrowheads="1"/>
                  </p:cNvPicPr>
                  <p:nvPr/>
                </p:nvPicPr>
                <p:blipFill>
                  <a:blip r:embed="rId8" cstate="print"/>
                  <a:srcRect/>
                  <a:stretch>
                    <a:fillRect/>
                  </a:stretch>
                </p:blipFill>
                <p:spPr bwMode="auto">
                  <a:xfrm>
                    <a:off x="2590802" y="1585927"/>
                    <a:ext cx="2232000" cy="2076411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</p:pic>
              <p:sp>
                <p:nvSpPr>
                  <p:cNvPr id="52" name="CasellaDiTesto 51"/>
                  <p:cNvSpPr txBox="1"/>
                  <p:nvPr/>
                </p:nvSpPr>
                <p:spPr>
                  <a:xfrm>
                    <a:off x="4064154" y="1729020"/>
                    <a:ext cx="1008112" cy="30290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it-IT" sz="800" b="1" dirty="0" smtClean="0">
                        <a:latin typeface="Times New Roman" pitchFamily="18" charset="0"/>
                        <a:cs typeface="Times New Roman" pitchFamily="18" charset="0"/>
                      </a:rPr>
                      <a:t>p=0.38</a:t>
                    </a:r>
                    <a:endParaRPr lang="it-IT" sz="8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</p:grpSp>
            <p:sp>
              <p:nvSpPr>
                <p:cNvPr id="53" name="Rettangolo 52"/>
                <p:cNvSpPr/>
                <p:nvPr/>
              </p:nvSpPr>
              <p:spPr>
                <a:xfrm>
                  <a:off x="131915" y="3501009"/>
                  <a:ext cx="6888357" cy="3312368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7" name="CasellaDiTesto 6"/>
                <p:cNvSpPr txBox="1"/>
                <p:nvPr/>
              </p:nvSpPr>
              <p:spPr>
                <a:xfrm>
                  <a:off x="2713371" y="3499693"/>
                  <a:ext cx="1584176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14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VHL-MUT-RCC </a:t>
                  </a:r>
                  <a:endParaRPr lang="it-IT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9" name="Gruppo 18"/>
              <p:cNvGrpSpPr/>
              <p:nvPr/>
            </p:nvGrpSpPr>
            <p:grpSpPr>
              <a:xfrm>
                <a:off x="5101065" y="595927"/>
                <a:ext cx="1071187" cy="229769"/>
                <a:chOff x="5220072" y="638046"/>
                <a:chExt cx="788498" cy="229769"/>
              </a:xfrm>
            </p:grpSpPr>
            <p:sp>
              <p:nvSpPr>
                <p:cNvPr id="15" name="Rettangolo 14"/>
                <p:cNvSpPr/>
                <p:nvPr/>
              </p:nvSpPr>
              <p:spPr>
                <a:xfrm>
                  <a:off x="5220072" y="638046"/>
                  <a:ext cx="324165" cy="177839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11" name="CasellaDiTesto 10"/>
                <p:cNvSpPr txBox="1"/>
                <p:nvPr/>
              </p:nvSpPr>
              <p:spPr>
                <a:xfrm>
                  <a:off x="5323726" y="652371"/>
                  <a:ext cx="68484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800" b="1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c</a:t>
                  </a:r>
                  <a:r>
                    <a:rPr lang="el-GR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γ</a:t>
                  </a:r>
                  <a:r>
                    <a:rPr lang="it-IT" sz="800" b="1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IIIa</a:t>
                  </a:r>
                  <a:endParaRPr lang="it-IT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58" name="Gruppo 57"/>
              <p:cNvGrpSpPr/>
              <p:nvPr/>
            </p:nvGrpSpPr>
            <p:grpSpPr>
              <a:xfrm>
                <a:off x="3393721" y="626394"/>
                <a:ext cx="781915" cy="229769"/>
                <a:chOff x="5148660" y="638046"/>
                <a:chExt cx="684844" cy="229769"/>
              </a:xfrm>
            </p:grpSpPr>
            <p:sp>
              <p:nvSpPr>
                <p:cNvPr id="59" name="Rettangolo 58"/>
                <p:cNvSpPr/>
                <p:nvPr/>
              </p:nvSpPr>
              <p:spPr>
                <a:xfrm>
                  <a:off x="5220072" y="638046"/>
                  <a:ext cx="324165" cy="177839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60" name="CasellaDiTesto 59"/>
                <p:cNvSpPr txBox="1"/>
                <p:nvPr/>
              </p:nvSpPr>
              <p:spPr>
                <a:xfrm>
                  <a:off x="5148660" y="652371"/>
                  <a:ext cx="68484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NAM-1</a:t>
                  </a:r>
                  <a:endParaRPr lang="it-IT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61" name="Gruppo 60"/>
              <p:cNvGrpSpPr/>
              <p:nvPr/>
            </p:nvGrpSpPr>
            <p:grpSpPr>
              <a:xfrm>
                <a:off x="1599251" y="576340"/>
                <a:ext cx="1510604" cy="367505"/>
                <a:chOff x="5220072" y="638046"/>
                <a:chExt cx="846927" cy="261967"/>
              </a:xfrm>
            </p:grpSpPr>
            <p:sp>
              <p:nvSpPr>
                <p:cNvPr id="62" name="Rettangolo 61"/>
                <p:cNvSpPr/>
                <p:nvPr/>
              </p:nvSpPr>
              <p:spPr>
                <a:xfrm>
                  <a:off x="5220072" y="638046"/>
                  <a:ext cx="324165" cy="177839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63" name="CasellaDiTesto 62"/>
                <p:cNvSpPr txBox="1"/>
                <p:nvPr/>
              </p:nvSpPr>
              <p:spPr>
                <a:xfrm>
                  <a:off x="5382155" y="684569"/>
                  <a:ext cx="68484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CAM-1</a:t>
                  </a:r>
                  <a:endParaRPr lang="it-IT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64" name="Gruppo 63"/>
              <p:cNvGrpSpPr/>
              <p:nvPr/>
            </p:nvGrpSpPr>
            <p:grpSpPr>
              <a:xfrm>
                <a:off x="1872511" y="2046226"/>
                <a:ext cx="883850" cy="229769"/>
                <a:chOff x="5220072" y="638046"/>
                <a:chExt cx="695871" cy="229769"/>
              </a:xfrm>
            </p:grpSpPr>
            <p:sp>
              <p:nvSpPr>
                <p:cNvPr id="65" name="Rettangolo 64"/>
                <p:cNvSpPr/>
                <p:nvPr/>
              </p:nvSpPr>
              <p:spPr>
                <a:xfrm>
                  <a:off x="5220072" y="638046"/>
                  <a:ext cx="324165" cy="177839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66" name="CasellaDiTesto 65"/>
                <p:cNvSpPr txBox="1"/>
                <p:nvPr/>
              </p:nvSpPr>
              <p:spPr>
                <a:xfrm>
                  <a:off x="5231099" y="652371"/>
                  <a:ext cx="68484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Kp46</a:t>
                  </a:r>
                  <a:endParaRPr lang="it-IT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67" name="Gruppo 66"/>
              <p:cNvGrpSpPr/>
              <p:nvPr/>
            </p:nvGrpSpPr>
            <p:grpSpPr>
              <a:xfrm>
                <a:off x="7025522" y="595927"/>
                <a:ext cx="883850" cy="229769"/>
                <a:chOff x="5220072" y="638046"/>
                <a:chExt cx="695871" cy="229769"/>
              </a:xfrm>
            </p:grpSpPr>
            <p:sp>
              <p:nvSpPr>
                <p:cNvPr id="68" name="Rettangolo 67"/>
                <p:cNvSpPr/>
                <p:nvPr/>
              </p:nvSpPr>
              <p:spPr>
                <a:xfrm>
                  <a:off x="5220072" y="638046"/>
                  <a:ext cx="324165" cy="177839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69" name="CasellaDiTesto 68"/>
                <p:cNvSpPr txBox="1"/>
                <p:nvPr/>
              </p:nvSpPr>
              <p:spPr>
                <a:xfrm>
                  <a:off x="5231099" y="652371"/>
                  <a:ext cx="68484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Kp30</a:t>
                  </a:r>
                  <a:endParaRPr lang="it-IT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70" name="Gruppo 69"/>
              <p:cNvGrpSpPr/>
              <p:nvPr/>
            </p:nvGrpSpPr>
            <p:grpSpPr>
              <a:xfrm>
                <a:off x="3535484" y="2062418"/>
                <a:ext cx="883850" cy="229769"/>
                <a:chOff x="5220072" y="638046"/>
                <a:chExt cx="695871" cy="229769"/>
              </a:xfrm>
            </p:grpSpPr>
            <p:sp>
              <p:nvSpPr>
                <p:cNvPr id="71" name="Rettangolo 70"/>
                <p:cNvSpPr/>
                <p:nvPr/>
              </p:nvSpPr>
              <p:spPr>
                <a:xfrm>
                  <a:off x="5220072" y="638046"/>
                  <a:ext cx="324165" cy="177839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72" name="CasellaDiTesto 71"/>
                <p:cNvSpPr txBox="1"/>
                <p:nvPr/>
              </p:nvSpPr>
              <p:spPr>
                <a:xfrm>
                  <a:off x="5231099" y="652371"/>
                  <a:ext cx="68484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Kp44</a:t>
                  </a:r>
                  <a:endParaRPr lang="it-IT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73" name="Gruppo 72"/>
              <p:cNvGrpSpPr/>
              <p:nvPr/>
            </p:nvGrpSpPr>
            <p:grpSpPr>
              <a:xfrm>
                <a:off x="5265141" y="2046227"/>
                <a:ext cx="883850" cy="230681"/>
                <a:chOff x="5220072" y="638046"/>
                <a:chExt cx="695871" cy="216879"/>
              </a:xfrm>
            </p:grpSpPr>
            <p:sp>
              <p:nvSpPr>
                <p:cNvPr id="74" name="Rettangolo 73"/>
                <p:cNvSpPr/>
                <p:nvPr/>
              </p:nvSpPr>
              <p:spPr>
                <a:xfrm>
                  <a:off x="5220072" y="638046"/>
                  <a:ext cx="324165" cy="177839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75" name="CasellaDiTesto 74"/>
                <p:cNvSpPr txBox="1"/>
                <p:nvPr/>
              </p:nvSpPr>
              <p:spPr>
                <a:xfrm>
                  <a:off x="5231099" y="652371"/>
                  <a:ext cx="684844" cy="202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KG2D</a:t>
                  </a:r>
                  <a:endParaRPr lang="it-IT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</p:grpSp>
      <p:grpSp>
        <p:nvGrpSpPr>
          <p:cNvPr id="57" name="Gruppo 56"/>
          <p:cNvGrpSpPr/>
          <p:nvPr/>
        </p:nvGrpSpPr>
        <p:grpSpPr>
          <a:xfrm>
            <a:off x="1049908" y="3505344"/>
            <a:ext cx="7244656" cy="3288753"/>
            <a:chOff x="1049908" y="3505344"/>
            <a:chExt cx="7244656" cy="3288753"/>
          </a:xfrm>
        </p:grpSpPr>
        <p:sp>
          <p:nvSpPr>
            <p:cNvPr id="55" name="CasellaDiTesto 54"/>
            <p:cNvSpPr txBox="1"/>
            <p:nvPr/>
          </p:nvSpPr>
          <p:spPr>
            <a:xfrm>
              <a:off x="1049908" y="3505344"/>
              <a:ext cx="36004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2" name="Gruppo 21"/>
            <p:cNvGrpSpPr/>
            <p:nvPr/>
          </p:nvGrpSpPr>
          <p:grpSpPr>
            <a:xfrm>
              <a:off x="1295636" y="3570088"/>
              <a:ext cx="6998928" cy="3224009"/>
              <a:chOff x="1295636" y="3570088"/>
              <a:chExt cx="6998928" cy="3224009"/>
            </a:xfrm>
          </p:grpSpPr>
          <p:grpSp>
            <p:nvGrpSpPr>
              <p:cNvPr id="21" name="Gruppo 20"/>
              <p:cNvGrpSpPr/>
              <p:nvPr/>
            </p:nvGrpSpPr>
            <p:grpSpPr>
              <a:xfrm>
                <a:off x="1295636" y="3570088"/>
                <a:ext cx="6998928" cy="3224009"/>
                <a:chOff x="1295636" y="3570088"/>
                <a:chExt cx="6998928" cy="3224009"/>
              </a:xfrm>
            </p:grpSpPr>
            <p:grpSp>
              <p:nvGrpSpPr>
                <p:cNvPr id="9" name="Gruppo 8"/>
                <p:cNvGrpSpPr/>
                <p:nvPr/>
              </p:nvGrpSpPr>
              <p:grpSpPr>
                <a:xfrm>
                  <a:off x="1295636" y="3570088"/>
                  <a:ext cx="6998928" cy="3224009"/>
                  <a:chOff x="93352" y="138499"/>
                  <a:chExt cx="6998928" cy="3362509"/>
                </a:xfrm>
              </p:grpSpPr>
              <p:grpSp>
                <p:nvGrpSpPr>
                  <p:cNvPr id="5" name="Gruppo 4"/>
                  <p:cNvGrpSpPr/>
                  <p:nvPr/>
                </p:nvGrpSpPr>
                <p:grpSpPr>
                  <a:xfrm>
                    <a:off x="93352" y="138499"/>
                    <a:ext cx="6998928" cy="3362509"/>
                    <a:chOff x="93352" y="-5517"/>
                    <a:chExt cx="6998928" cy="3362509"/>
                  </a:xfrm>
                </p:grpSpPr>
                <p:grpSp>
                  <p:nvGrpSpPr>
                    <p:cNvPr id="3" name="Gruppo 2"/>
                    <p:cNvGrpSpPr/>
                    <p:nvPr/>
                  </p:nvGrpSpPr>
                  <p:grpSpPr>
                    <a:xfrm>
                      <a:off x="93352" y="234342"/>
                      <a:ext cx="6998928" cy="3122650"/>
                      <a:chOff x="93352" y="234342"/>
                      <a:chExt cx="6998928" cy="3122650"/>
                    </a:xfrm>
                  </p:grpSpPr>
                  <p:grpSp>
                    <p:nvGrpSpPr>
                      <p:cNvPr id="26" name="Gruppo 25"/>
                      <p:cNvGrpSpPr/>
                      <p:nvPr/>
                    </p:nvGrpSpPr>
                    <p:grpSpPr>
                      <a:xfrm>
                        <a:off x="3588209" y="1772816"/>
                        <a:ext cx="1800000" cy="1548000"/>
                        <a:chOff x="5724128" y="3429000"/>
                        <a:chExt cx="2520280" cy="2088000"/>
                      </a:xfrm>
                    </p:grpSpPr>
                    <p:pic>
                      <p:nvPicPr>
                        <p:cNvPr id="6" name="Picture 5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9" cstate="print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5724128" y="3429000"/>
                          <a:ext cx="2248625" cy="2088000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</p:pic>
                    <p:sp>
                      <p:nvSpPr>
                        <p:cNvPr id="18" name="CasellaDiTesto 17"/>
                        <p:cNvSpPr txBox="1"/>
                        <p:nvPr/>
                      </p:nvSpPr>
                      <p:spPr>
                        <a:xfrm>
                          <a:off x="7236296" y="3573016"/>
                          <a:ext cx="1008112" cy="21544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it-IT" sz="800" b="1" dirty="0" smtClean="0">
                              <a:latin typeface="Times New Roman" pitchFamily="18" charset="0"/>
                              <a:cs typeface="Times New Roman" pitchFamily="18" charset="0"/>
                            </a:rPr>
                            <a:t>p=0.65</a:t>
                          </a:r>
                          <a:endParaRPr lang="it-IT" sz="800" b="1" dirty="0">
                            <a:latin typeface="Times New Roman" pitchFamily="18" charset="0"/>
                            <a:cs typeface="Times New Roman" pitchFamily="18" charset="0"/>
                          </a:endParaRPr>
                        </a:p>
                      </p:txBody>
                    </p:sp>
                  </p:grpSp>
                  <p:grpSp>
                    <p:nvGrpSpPr>
                      <p:cNvPr id="36" name="Gruppo 35"/>
                      <p:cNvGrpSpPr/>
                      <p:nvPr/>
                    </p:nvGrpSpPr>
                    <p:grpSpPr>
                      <a:xfrm>
                        <a:off x="1847987" y="242439"/>
                        <a:ext cx="1807909" cy="1548000"/>
                        <a:chOff x="2590802" y="1585927"/>
                        <a:chExt cx="2568499" cy="2089807"/>
                      </a:xfrm>
                    </p:grpSpPr>
                    <p:pic>
                      <p:nvPicPr>
                        <p:cNvPr id="2057" name="Picture 9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0" cstate="print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590802" y="1585927"/>
                          <a:ext cx="2246400" cy="2089807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</p:pic>
                    <p:sp>
                      <p:nvSpPr>
                        <p:cNvPr id="13" name="CasellaDiTesto 12"/>
                        <p:cNvSpPr txBox="1"/>
                        <p:nvPr/>
                      </p:nvSpPr>
                      <p:spPr>
                        <a:xfrm>
                          <a:off x="4151189" y="1725922"/>
                          <a:ext cx="1008112" cy="21544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it-IT" sz="800" b="1" dirty="0" smtClean="0">
                              <a:latin typeface="Times New Roman" pitchFamily="18" charset="0"/>
                              <a:cs typeface="Times New Roman" pitchFamily="18" charset="0"/>
                            </a:rPr>
                            <a:t>p=0.92</a:t>
                          </a:r>
                          <a:endParaRPr lang="it-IT" sz="800" b="1" dirty="0">
                            <a:latin typeface="Times New Roman" pitchFamily="18" charset="0"/>
                            <a:cs typeface="Times New Roman" pitchFamily="18" charset="0"/>
                          </a:endParaRPr>
                        </a:p>
                      </p:txBody>
                    </p:sp>
                  </p:grpSp>
                  <p:grpSp>
                    <p:nvGrpSpPr>
                      <p:cNvPr id="38" name="Gruppo 37"/>
                      <p:cNvGrpSpPr/>
                      <p:nvPr/>
                    </p:nvGrpSpPr>
                    <p:grpSpPr>
                      <a:xfrm>
                        <a:off x="93352" y="276998"/>
                        <a:ext cx="1800000" cy="1548000"/>
                        <a:chOff x="467544" y="1340768"/>
                        <a:chExt cx="2592288" cy="2088000"/>
                      </a:xfrm>
                    </p:grpSpPr>
                    <p:pic>
                      <p:nvPicPr>
                        <p:cNvPr id="2058" name="Picture 10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1" cstate="print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467544" y="1340768"/>
                          <a:ext cx="2244465" cy="2088000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</p:pic>
                    <p:sp>
                      <p:nvSpPr>
                        <p:cNvPr id="12" name="CasellaDiTesto 11"/>
                        <p:cNvSpPr txBox="1"/>
                        <p:nvPr/>
                      </p:nvSpPr>
                      <p:spPr>
                        <a:xfrm>
                          <a:off x="2051720" y="1556792"/>
                          <a:ext cx="1008112" cy="21544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it-IT" sz="800" b="1" dirty="0" smtClean="0">
                              <a:latin typeface="Times New Roman" pitchFamily="18" charset="0"/>
                              <a:cs typeface="Times New Roman" pitchFamily="18" charset="0"/>
                            </a:rPr>
                            <a:t>p=0.22</a:t>
                          </a:r>
                          <a:endParaRPr lang="it-IT" sz="800" b="1" dirty="0">
                            <a:latin typeface="Times New Roman" pitchFamily="18" charset="0"/>
                            <a:cs typeface="Times New Roman" pitchFamily="18" charset="0"/>
                          </a:endParaRPr>
                        </a:p>
                      </p:txBody>
                    </p:sp>
                  </p:grpSp>
                  <p:grpSp>
                    <p:nvGrpSpPr>
                      <p:cNvPr id="40" name="Gruppo 39"/>
                      <p:cNvGrpSpPr/>
                      <p:nvPr/>
                    </p:nvGrpSpPr>
                    <p:grpSpPr>
                      <a:xfrm>
                        <a:off x="3588208" y="242439"/>
                        <a:ext cx="1800000" cy="1548000"/>
                        <a:chOff x="4788024" y="1268760"/>
                        <a:chExt cx="2520280" cy="2088000"/>
                      </a:xfrm>
                    </p:grpSpPr>
                    <p:pic>
                      <p:nvPicPr>
                        <p:cNvPr id="2059" name="Picture 11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2" cstate="print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4788024" y="1268760"/>
                          <a:ext cx="2244465" cy="2088000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</p:pic>
                    <p:sp>
                      <p:nvSpPr>
                        <p:cNvPr id="14" name="CasellaDiTesto 13"/>
                        <p:cNvSpPr txBox="1"/>
                        <p:nvPr/>
                      </p:nvSpPr>
                      <p:spPr>
                        <a:xfrm>
                          <a:off x="6300192" y="1484784"/>
                          <a:ext cx="1008112" cy="21544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it-IT" sz="800" b="1" dirty="0" smtClean="0">
                              <a:latin typeface="Times New Roman" pitchFamily="18" charset="0"/>
                              <a:cs typeface="Times New Roman" pitchFamily="18" charset="0"/>
                            </a:rPr>
                            <a:t>p=0.04</a:t>
                          </a:r>
                          <a:endParaRPr lang="it-IT" sz="800" b="1" dirty="0">
                            <a:latin typeface="Times New Roman" pitchFamily="18" charset="0"/>
                            <a:cs typeface="Times New Roman" pitchFamily="18" charset="0"/>
                          </a:endParaRPr>
                        </a:p>
                      </p:txBody>
                    </p:sp>
                  </p:grpSp>
                  <p:grpSp>
                    <p:nvGrpSpPr>
                      <p:cNvPr id="43" name="Gruppo 42"/>
                      <p:cNvGrpSpPr/>
                      <p:nvPr/>
                    </p:nvGrpSpPr>
                    <p:grpSpPr>
                      <a:xfrm>
                        <a:off x="5292280" y="234342"/>
                        <a:ext cx="1800000" cy="1548000"/>
                        <a:chOff x="0" y="3429000"/>
                        <a:chExt cx="2555776" cy="2088000"/>
                      </a:xfrm>
                    </p:grpSpPr>
                    <p:pic>
                      <p:nvPicPr>
                        <p:cNvPr id="2060" name="Picture 12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3" cstate="print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0" y="3429000"/>
                          <a:ext cx="2244465" cy="2088000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</p:pic>
                    <p:sp>
                      <p:nvSpPr>
                        <p:cNvPr id="42" name="CasellaDiTesto 41"/>
                        <p:cNvSpPr txBox="1"/>
                        <p:nvPr/>
                      </p:nvSpPr>
                      <p:spPr>
                        <a:xfrm>
                          <a:off x="1547664" y="3645024"/>
                          <a:ext cx="1008112" cy="21544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it-IT" sz="800" b="1" dirty="0" smtClean="0">
                              <a:latin typeface="Times New Roman" pitchFamily="18" charset="0"/>
                              <a:cs typeface="Times New Roman" pitchFamily="18" charset="0"/>
                            </a:rPr>
                            <a:t>p=0.18</a:t>
                          </a:r>
                          <a:endParaRPr lang="it-IT" sz="800" b="1" dirty="0">
                            <a:latin typeface="Times New Roman" pitchFamily="18" charset="0"/>
                            <a:cs typeface="Times New Roman" pitchFamily="18" charset="0"/>
                          </a:endParaRPr>
                        </a:p>
                      </p:txBody>
                    </p:sp>
                  </p:grpSp>
                  <p:grpSp>
                    <p:nvGrpSpPr>
                      <p:cNvPr id="45" name="Gruppo 44"/>
                      <p:cNvGrpSpPr/>
                      <p:nvPr/>
                    </p:nvGrpSpPr>
                    <p:grpSpPr>
                      <a:xfrm>
                        <a:off x="1893352" y="1808992"/>
                        <a:ext cx="1800000" cy="1548000"/>
                        <a:chOff x="3491880" y="3717032"/>
                        <a:chExt cx="2520280" cy="2088000"/>
                      </a:xfrm>
                    </p:grpSpPr>
                    <p:pic>
                      <p:nvPicPr>
                        <p:cNvPr id="2061" name="Picture 13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4" cstate="print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491880" y="3717032"/>
                          <a:ext cx="2244465" cy="2088000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</p:pic>
                    <p:sp>
                      <p:nvSpPr>
                        <p:cNvPr id="17" name="CasellaDiTesto 16"/>
                        <p:cNvSpPr txBox="1"/>
                        <p:nvPr/>
                      </p:nvSpPr>
                      <p:spPr>
                        <a:xfrm>
                          <a:off x="5004048" y="3861048"/>
                          <a:ext cx="1008112" cy="21544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it-IT" sz="800" b="1" dirty="0" smtClean="0">
                              <a:latin typeface="Times New Roman" pitchFamily="18" charset="0"/>
                              <a:cs typeface="Times New Roman" pitchFamily="18" charset="0"/>
                            </a:rPr>
                            <a:t>p=0.15</a:t>
                          </a:r>
                          <a:endParaRPr lang="it-IT" sz="800" b="1" dirty="0">
                            <a:latin typeface="Times New Roman" pitchFamily="18" charset="0"/>
                            <a:cs typeface="Times New Roman" pitchFamily="18" charset="0"/>
                          </a:endParaRPr>
                        </a:p>
                      </p:txBody>
                    </p:sp>
                  </p:grpSp>
                  <p:grpSp>
                    <p:nvGrpSpPr>
                      <p:cNvPr id="47" name="Gruppo 46"/>
                      <p:cNvGrpSpPr/>
                      <p:nvPr/>
                    </p:nvGrpSpPr>
                    <p:grpSpPr>
                      <a:xfrm>
                        <a:off x="129356" y="1808992"/>
                        <a:ext cx="1800000" cy="1548000"/>
                        <a:chOff x="1979712" y="3933056"/>
                        <a:chExt cx="2520280" cy="2088000"/>
                      </a:xfrm>
                    </p:grpSpPr>
                    <p:pic>
                      <p:nvPicPr>
                        <p:cNvPr id="2062" name="Picture 14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5" cstate="print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979712" y="3933056"/>
                          <a:ext cx="2244465" cy="2088000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</p:pic>
                    <p:sp>
                      <p:nvSpPr>
                        <p:cNvPr id="16" name="CasellaDiTesto 15"/>
                        <p:cNvSpPr txBox="1"/>
                        <p:nvPr/>
                      </p:nvSpPr>
                      <p:spPr>
                        <a:xfrm>
                          <a:off x="3491880" y="4077072"/>
                          <a:ext cx="1008112" cy="21544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it-IT" sz="800" b="1" dirty="0" smtClean="0">
                              <a:latin typeface="Times New Roman" pitchFamily="18" charset="0"/>
                              <a:cs typeface="Times New Roman" pitchFamily="18" charset="0"/>
                            </a:rPr>
                            <a:t>p=0.88</a:t>
                          </a:r>
                          <a:endParaRPr lang="it-IT" sz="800" b="1" dirty="0">
                            <a:latin typeface="Times New Roman" pitchFamily="18" charset="0"/>
                            <a:cs typeface="Times New Roman" pitchFamily="18" charset="0"/>
                          </a:endParaRPr>
                        </a:p>
                      </p:txBody>
                    </p:sp>
                  </p:grpSp>
                </p:grpSp>
                <p:sp>
                  <p:nvSpPr>
                    <p:cNvPr id="2" name="Rettangolo 1"/>
                    <p:cNvSpPr/>
                    <p:nvPr/>
                  </p:nvSpPr>
                  <p:spPr>
                    <a:xfrm>
                      <a:off x="129356" y="-5517"/>
                      <a:ext cx="6888357" cy="3326333"/>
                    </a:xfrm>
                    <a:prstGeom prst="rect">
                      <a:avLst/>
                    </a:prstGeom>
                    <a:noFill/>
                    <a:ln w="952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it-IT"/>
                    </a:p>
                  </p:txBody>
                </p:sp>
              </p:grpSp>
              <p:sp>
                <p:nvSpPr>
                  <p:cNvPr id="54" name="CasellaDiTesto 53"/>
                  <p:cNvSpPr txBox="1"/>
                  <p:nvPr/>
                </p:nvSpPr>
                <p:spPr>
                  <a:xfrm>
                    <a:off x="2805537" y="150245"/>
                    <a:ext cx="1584176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it-IT" sz="14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VHL-WT-RCC </a:t>
                    </a:r>
                    <a:endParaRPr lang="it-IT" sz="14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77" name="Gruppo 76"/>
                <p:cNvGrpSpPr/>
                <p:nvPr/>
              </p:nvGrpSpPr>
              <p:grpSpPr>
                <a:xfrm>
                  <a:off x="5390039" y="3768321"/>
                  <a:ext cx="1200454" cy="215444"/>
                  <a:chOff x="5220072" y="625551"/>
                  <a:chExt cx="883651" cy="215444"/>
                </a:xfrm>
              </p:grpSpPr>
              <p:sp>
                <p:nvSpPr>
                  <p:cNvPr id="78" name="Rettangolo 77"/>
                  <p:cNvSpPr/>
                  <p:nvPr/>
                </p:nvSpPr>
                <p:spPr>
                  <a:xfrm>
                    <a:off x="5220072" y="638046"/>
                    <a:ext cx="489983" cy="195186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it-IT"/>
                  </a:p>
                </p:txBody>
              </p:sp>
              <p:sp>
                <p:nvSpPr>
                  <p:cNvPr id="79" name="CasellaDiTesto 78"/>
                  <p:cNvSpPr txBox="1"/>
                  <p:nvPr/>
                </p:nvSpPr>
                <p:spPr>
                  <a:xfrm>
                    <a:off x="5260076" y="625551"/>
                    <a:ext cx="843647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it-IT" sz="800" b="1" dirty="0" err="1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Fc</a:t>
                    </a:r>
                    <a:r>
                      <a:rPr lang="el-GR" sz="8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γ</a:t>
                    </a:r>
                    <a:r>
                      <a:rPr lang="it-IT" sz="800" b="1" dirty="0" err="1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RIIIa</a:t>
                    </a:r>
                    <a:endParaRPr lang="it-IT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80" name="Gruppo 79"/>
                <p:cNvGrpSpPr/>
                <p:nvPr/>
              </p:nvGrpSpPr>
              <p:grpSpPr>
                <a:xfrm>
                  <a:off x="3677118" y="3798402"/>
                  <a:ext cx="988797" cy="215444"/>
                  <a:chOff x="5201815" y="620272"/>
                  <a:chExt cx="684844" cy="215444"/>
                </a:xfrm>
              </p:grpSpPr>
              <p:sp>
                <p:nvSpPr>
                  <p:cNvPr id="81" name="Rettangolo 80"/>
                  <p:cNvSpPr/>
                  <p:nvPr/>
                </p:nvSpPr>
                <p:spPr>
                  <a:xfrm>
                    <a:off x="5220072" y="638046"/>
                    <a:ext cx="324165" cy="177839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it-IT"/>
                  </a:p>
                </p:txBody>
              </p:sp>
              <p:sp>
                <p:nvSpPr>
                  <p:cNvPr id="82" name="CasellaDiTesto 81"/>
                  <p:cNvSpPr txBox="1"/>
                  <p:nvPr/>
                </p:nvSpPr>
                <p:spPr>
                  <a:xfrm>
                    <a:off x="5201815" y="620272"/>
                    <a:ext cx="684844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it-IT" sz="8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DNAM-1</a:t>
                    </a:r>
                    <a:endParaRPr lang="it-IT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83" name="Gruppo 82"/>
                <p:cNvGrpSpPr/>
                <p:nvPr/>
              </p:nvGrpSpPr>
              <p:grpSpPr>
                <a:xfrm>
                  <a:off x="1691680" y="3781575"/>
                  <a:ext cx="1510604" cy="367505"/>
                  <a:chOff x="5220072" y="638046"/>
                  <a:chExt cx="846927" cy="261967"/>
                </a:xfrm>
              </p:grpSpPr>
              <p:sp>
                <p:nvSpPr>
                  <p:cNvPr id="84" name="Rettangolo 83"/>
                  <p:cNvSpPr/>
                  <p:nvPr/>
                </p:nvSpPr>
                <p:spPr>
                  <a:xfrm>
                    <a:off x="5220072" y="638046"/>
                    <a:ext cx="324165" cy="177839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it-IT"/>
                  </a:p>
                </p:txBody>
              </p:sp>
              <p:sp>
                <p:nvSpPr>
                  <p:cNvPr id="85" name="CasellaDiTesto 84"/>
                  <p:cNvSpPr txBox="1"/>
                  <p:nvPr/>
                </p:nvSpPr>
                <p:spPr>
                  <a:xfrm>
                    <a:off x="5382155" y="684569"/>
                    <a:ext cx="684844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it-IT" sz="8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NCAM-1</a:t>
                    </a:r>
                    <a:endParaRPr lang="it-IT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86" name="Gruppo 85"/>
                <p:cNvGrpSpPr/>
                <p:nvPr/>
              </p:nvGrpSpPr>
              <p:grpSpPr>
                <a:xfrm>
                  <a:off x="7025517" y="3728900"/>
                  <a:ext cx="1049791" cy="232489"/>
                  <a:chOff x="5155340" y="620975"/>
                  <a:chExt cx="826520" cy="232489"/>
                </a:xfrm>
              </p:grpSpPr>
              <p:sp>
                <p:nvSpPr>
                  <p:cNvPr id="87" name="Rettangolo 86"/>
                  <p:cNvSpPr/>
                  <p:nvPr/>
                </p:nvSpPr>
                <p:spPr>
                  <a:xfrm>
                    <a:off x="5155340" y="638046"/>
                    <a:ext cx="388897" cy="215418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it-IT"/>
                  </a:p>
                </p:txBody>
              </p:sp>
              <p:sp>
                <p:nvSpPr>
                  <p:cNvPr id="88" name="CasellaDiTesto 87"/>
                  <p:cNvSpPr txBox="1"/>
                  <p:nvPr/>
                </p:nvSpPr>
                <p:spPr>
                  <a:xfrm>
                    <a:off x="5297016" y="620975"/>
                    <a:ext cx="684844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it-IT" sz="8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NKp30</a:t>
                    </a:r>
                    <a:endParaRPr lang="it-IT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</p:grpSp>
          <p:grpSp>
            <p:nvGrpSpPr>
              <p:cNvPr id="90" name="Gruppo 89"/>
              <p:cNvGrpSpPr/>
              <p:nvPr/>
            </p:nvGrpSpPr>
            <p:grpSpPr>
              <a:xfrm>
                <a:off x="1951704" y="5271271"/>
                <a:ext cx="883850" cy="229769"/>
                <a:chOff x="5220072" y="638046"/>
                <a:chExt cx="695871" cy="229769"/>
              </a:xfrm>
            </p:grpSpPr>
            <p:sp>
              <p:nvSpPr>
                <p:cNvPr id="91" name="Rettangolo 90"/>
                <p:cNvSpPr/>
                <p:nvPr/>
              </p:nvSpPr>
              <p:spPr>
                <a:xfrm>
                  <a:off x="5220072" y="638046"/>
                  <a:ext cx="324165" cy="177839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92" name="CasellaDiTesto 91"/>
                <p:cNvSpPr txBox="1"/>
                <p:nvPr/>
              </p:nvSpPr>
              <p:spPr>
                <a:xfrm>
                  <a:off x="5231099" y="652371"/>
                  <a:ext cx="68484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Kp46</a:t>
                  </a:r>
                  <a:endParaRPr lang="it-IT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93" name="Gruppo 92"/>
              <p:cNvGrpSpPr/>
              <p:nvPr/>
            </p:nvGrpSpPr>
            <p:grpSpPr>
              <a:xfrm>
                <a:off x="3722151" y="5279346"/>
                <a:ext cx="883850" cy="229769"/>
                <a:chOff x="5220072" y="638046"/>
                <a:chExt cx="695871" cy="229769"/>
              </a:xfrm>
            </p:grpSpPr>
            <p:sp>
              <p:nvSpPr>
                <p:cNvPr id="94" name="Rettangolo 93"/>
                <p:cNvSpPr/>
                <p:nvPr/>
              </p:nvSpPr>
              <p:spPr>
                <a:xfrm>
                  <a:off x="5220072" y="638046"/>
                  <a:ext cx="324165" cy="177839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95" name="CasellaDiTesto 94"/>
                <p:cNvSpPr txBox="1"/>
                <p:nvPr/>
              </p:nvSpPr>
              <p:spPr>
                <a:xfrm>
                  <a:off x="5231099" y="652371"/>
                  <a:ext cx="68484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Kp44</a:t>
                  </a:r>
                  <a:endParaRPr lang="it-IT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96" name="Gruppo 95"/>
              <p:cNvGrpSpPr/>
              <p:nvPr/>
            </p:nvGrpSpPr>
            <p:grpSpPr>
              <a:xfrm>
                <a:off x="5344334" y="5271272"/>
                <a:ext cx="883850" cy="230681"/>
                <a:chOff x="5220072" y="638046"/>
                <a:chExt cx="695871" cy="216879"/>
              </a:xfrm>
            </p:grpSpPr>
            <p:sp>
              <p:nvSpPr>
                <p:cNvPr id="97" name="Rettangolo 96"/>
                <p:cNvSpPr/>
                <p:nvPr/>
              </p:nvSpPr>
              <p:spPr>
                <a:xfrm>
                  <a:off x="5220072" y="638046"/>
                  <a:ext cx="324165" cy="177839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98" name="CasellaDiTesto 97"/>
                <p:cNvSpPr txBox="1"/>
                <p:nvPr/>
              </p:nvSpPr>
              <p:spPr>
                <a:xfrm>
                  <a:off x="5231099" y="652371"/>
                  <a:ext cx="684844" cy="202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KG2D</a:t>
                  </a:r>
                  <a:endParaRPr lang="it-IT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60577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285</TotalTime>
  <Words>38</Words>
  <Application>Microsoft Office PowerPoint</Application>
  <PresentationFormat>Presentazione su schermo (4:3)</PresentationFormat>
  <Paragraphs>33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CALA</dc:creator>
  <cp:lastModifiedBy>Genomica Funzionale</cp:lastModifiedBy>
  <cp:revision>621</cp:revision>
  <dcterms:created xsi:type="dcterms:W3CDTF">2016-04-07T07:01:43Z</dcterms:created>
  <dcterms:modified xsi:type="dcterms:W3CDTF">2018-10-15T14:52:48Z</dcterms:modified>
</cp:coreProperties>
</file>